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14" autoAdjust="0"/>
    <p:restoredTop sz="94660"/>
  </p:normalViewPr>
  <p:slideViewPr>
    <p:cSldViewPr snapToGrid="0">
      <p:cViewPr varScale="1">
        <p:scale>
          <a:sx n="86" d="100"/>
          <a:sy n="86" d="100"/>
        </p:scale>
        <p:origin x="102" y="5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27AB5D-D1AD-4670-9EC6-937AC09A7930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CC03B1C-1394-4E8F-A765-94F6315893C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72775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6F95A-7C01-41C9-A564-05D45DF9F9CE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B3001-1258-4479-B2E1-BAD369789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7409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6F95A-7C01-41C9-A564-05D45DF9F9CE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B3001-1258-4479-B2E1-BAD369789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44247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6F95A-7C01-41C9-A564-05D45DF9F9CE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B3001-1258-4479-B2E1-BAD369789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1776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6F95A-7C01-41C9-A564-05D45DF9F9CE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B3001-1258-4479-B2E1-BAD369789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0535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6F95A-7C01-41C9-A564-05D45DF9F9CE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B3001-1258-4479-B2E1-BAD369789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34807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6F95A-7C01-41C9-A564-05D45DF9F9CE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B3001-1258-4479-B2E1-BAD369789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1920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6F95A-7C01-41C9-A564-05D45DF9F9CE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B3001-1258-4479-B2E1-BAD369789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8265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6F95A-7C01-41C9-A564-05D45DF9F9CE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B3001-1258-4479-B2E1-BAD369789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643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6F95A-7C01-41C9-A564-05D45DF9F9CE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B3001-1258-4479-B2E1-BAD369789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635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6F95A-7C01-41C9-A564-05D45DF9F9CE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B3001-1258-4479-B2E1-BAD369789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3159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E6F95A-7C01-41C9-A564-05D45DF9F9CE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AB3001-1258-4479-B2E1-BAD369789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3103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E6F95A-7C01-41C9-A564-05D45DF9F9CE}" type="datetimeFigureOut">
              <a:rPr lang="en-US" smtClean="0"/>
              <a:t>8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AB3001-1258-4479-B2E1-BAD369789C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60399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3680" y="2943956"/>
            <a:ext cx="3707900" cy="2709678"/>
          </a:xfrm>
          <a:prstGeom prst="rect">
            <a:avLst/>
          </a:prstGeom>
        </p:spPr>
      </p:pic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0330534"/>
              </p:ext>
            </p:extLst>
          </p:nvPr>
        </p:nvGraphicFramePr>
        <p:xfrm>
          <a:off x="6155473" y="3122341"/>
          <a:ext cx="3111191" cy="234796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94014"/>
                <a:gridCol w="1738761"/>
                <a:gridCol w="478416"/>
              </a:tblGrid>
              <a:tr h="248326"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ameter</a:t>
                      </a:r>
                      <a:endParaRPr 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bservations</a:t>
                      </a:r>
                      <a:endParaRPr 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ore</a:t>
                      </a:r>
                      <a:endParaRPr lang="en-US" sz="9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48326">
                <a:tc rowSpan="4"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ral Appearance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483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duced grooming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48326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cular/nasal discharge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61361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ence</a:t>
                      </a:r>
                      <a:r>
                        <a:rPr lang="en-US" sz="9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of grooming, hunched posture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48326">
                <a:tc rowSpan="4"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ehavior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</a:t>
                      </a: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483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creased activity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48326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bored or</a:t>
                      </a:r>
                      <a:r>
                        <a:rPr lang="en-US" sz="9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rapid breathing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248326"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thargic, depressed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9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</a:tbl>
          </a:graphicData>
        </a:graphic>
      </p:graphicFrame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3680" y="245364"/>
            <a:ext cx="3598171" cy="2709678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86858" y="245364"/>
            <a:ext cx="3739904" cy="270967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5776069" y="3022013"/>
            <a:ext cx="20011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371253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</TotalTime>
  <Words>36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DH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gum, Lauren H</dc:creator>
  <cp:lastModifiedBy>Mangum, Lauren H</cp:lastModifiedBy>
  <cp:revision>6</cp:revision>
  <dcterms:created xsi:type="dcterms:W3CDTF">2018-08-13T18:04:44Z</dcterms:created>
  <dcterms:modified xsi:type="dcterms:W3CDTF">2018-08-15T19:16:47Z</dcterms:modified>
</cp:coreProperties>
</file>